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oni Stefano" userId="62fae984-f9ea-4331-af08-82d62adaac1e" providerId="ADAL" clId="{9433CCC6-4DEF-47CF-9334-6609860C5EBE}"/>
    <pc:docChg chg="custSel modSld">
      <pc:chgData name="Poni Stefano" userId="62fae984-f9ea-4331-af08-82d62adaac1e" providerId="ADAL" clId="{9433CCC6-4DEF-47CF-9334-6609860C5EBE}" dt="2023-07-03T10:29:07.588" v="20" actId="20577"/>
      <pc:docMkLst>
        <pc:docMk/>
      </pc:docMkLst>
      <pc:sldChg chg="addSp delSp modSp mod">
        <pc:chgData name="Poni Stefano" userId="62fae984-f9ea-4331-af08-82d62adaac1e" providerId="ADAL" clId="{9433CCC6-4DEF-47CF-9334-6609860C5EBE}" dt="2023-07-03T10:29:07.588" v="20" actId="20577"/>
        <pc:sldMkLst>
          <pc:docMk/>
          <pc:sldMk cId="3819799624" sldId="262"/>
        </pc:sldMkLst>
        <pc:spChg chg="del">
          <ac:chgData name="Poni Stefano" userId="62fae984-f9ea-4331-af08-82d62adaac1e" providerId="ADAL" clId="{9433CCC6-4DEF-47CF-9334-6609860C5EBE}" dt="2023-07-03T10:27:29.093" v="2" actId="478"/>
          <ac:spMkLst>
            <pc:docMk/>
            <pc:sldMk cId="3819799624" sldId="262"/>
            <ac:spMk id="3" creationId="{597621D3-6D5A-7EDD-E117-AE16372796F7}"/>
          </ac:spMkLst>
        </pc:spChg>
        <pc:spChg chg="add mod">
          <ac:chgData name="Poni Stefano" userId="62fae984-f9ea-4331-af08-82d62adaac1e" providerId="ADAL" clId="{9433CCC6-4DEF-47CF-9334-6609860C5EBE}" dt="2023-07-03T10:29:07.588" v="20" actId="20577"/>
          <ac:spMkLst>
            <pc:docMk/>
            <pc:sldMk cId="3819799624" sldId="262"/>
            <ac:spMk id="5" creationId="{B8430196-7DBF-5CB4-14CB-5CC9831CF7F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CAE9E6-4B71-5724-02E7-43EC539E1F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95BC214-0281-0E97-5C4B-343EBBEF4E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256FBD-32D3-0556-E4B4-1657CF0BD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9204744-E86C-6900-C11A-A7CC1FCC4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8A44683-9BC2-C800-61B3-5B59D5F98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659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02E670-657F-0677-20C4-C62FC477B7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C4512F1-A453-0A39-ECFD-699F3C68A4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FF59885-51DB-FF4C-E6F4-ECEE53280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84349F6-9469-2CB5-4EBC-A9B78B16D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25E97DA-0A0B-801F-EB3D-90841A505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6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BFDC679-DC51-99F4-0E4F-48A9D77B10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7573E9-10FC-C6F3-BD49-CFD655EC6F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DD91718-0172-4034-5156-E21DD94C8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863B40B-9B17-9C36-5523-40F27FF3F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EFE366-6513-C17B-8CE4-684833640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619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8DAD7E-B272-5D99-DABB-4E4A49D8B4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F889BDD-B224-79AF-F79B-04DF12717F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3DA0633-C66F-95A2-0A58-36147BBA6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CDAC1C-72B2-1FDF-D097-22A84EC17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A6FA59E-DAF3-ACFF-320D-FB3B7A698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18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4F6A4F-204F-4E6F-2E76-68CD7FD1D2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DC0A6BA-B360-B473-7912-6F20251A7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8914F47-4173-B3E4-0D0A-BA440B301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377D75C-A10F-AF7E-5BAD-C00872ADE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3504818-040C-A745-B5F3-F5EEAF6AF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699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6CD37C-30A4-1C7C-F049-AE33F5871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C3547F1-E9EF-3EAA-1F2E-8D575B1342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51E86DE-2C26-5F36-74F8-0E179478FA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4573FA1-284A-4EF0-F26C-38BD77094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AE3B5D-1B3B-5217-56FB-14C977C8C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6C46723-1C84-EA18-5C5E-927142C7A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376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AFCE88-E9CE-AD14-B1F1-4A05EA55F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D071940-FC52-C769-D5C5-3C5ACFA3DB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9EA7AEB-B28C-DAF5-955C-59F5BE4C11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C0C2D15-BD8C-1F9A-F40E-FB5AF528D9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13C54E9-157E-C571-E0B8-F6BA37FD2E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A1E5334-1228-D6BD-B49F-7184A78A0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D305484-1CD8-A025-39FF-BCAE0444D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7C8FAD5-24AA-83B1-D3E8-B3320D53A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16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CDF02B-5A6F-13AA-8DD3-425A1993E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60CF616-0A43-AB68-B1E6-CADAA66A2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0BA1B3B-497B-4D83-AF36-3641D3928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C32B95A-8610-5AF2-4306-853545A41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664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4E06DAE-69BF-986D-7EB4-47D945FFD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F4799E1-72DF-76B4-C20A-BC06C1B0E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E541E45-5DA1-C999-7E6A-FAD3F167A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02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C4B62E4-B63D-C5C9-5CE8-CC1BE3AE9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96A7A63-DC03-437E-AD4E-EBE83AA5D9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A479FBF-F909-831E-825A-34282AE02E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D8D3792-7C4E-425A-EA7C-369A35F7E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C0D81D7-0E5B-2F31-B62E-DF963073A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FCB1743-23E2-E572-0A0E-5866EABC6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5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E83C2FD-2676-BE12-D93A-2F49999BC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1C07F55-4CAB-3FC4-3B3E-921FBB2147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A06CB44-B0E6-6831-22DE-4AF78FE5D7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6D7954-B5DD-D025-32CE-C62B07B23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7FD2C60-7E7D-EC4F-6B47-5705BE29F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3452509-B58F-DC18-0F4F-CBE476972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976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693D6D2-A363-34EE-BD25-6857E8C4CB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FD45A41-EAB5-BD94-8C64-310F9DE4A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BB2728-DE00-29B8-9340-04F62DE440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D88D3-9920-4685-8514-61B0EA11D387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ACBA32-1848-D22E-86BE-A33125476A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3B6A342-E8F4-FBA1-197D-7A60819E11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46097A-FF6E-41B7-A8E6-1101927B57A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460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D3C2A905-E093-1405-DF1A-97FA44E8F926}"/>
              </a:ext>
            </a:extLst>
          </p:cNvPr>
          <p:cNvGrpSpPr/>
          <p:nvPr/>
        </p:nvGrpSpPr>
        <p:grpSpPr>
          <a:xfrm>
            <a:off x="914401" y="1176370"/>
            <a:ext cx="10450286" cy="4318739"/>
            <a:chOff x="1612357" y="1176370"/>
            <a:chExt cx="8901679" cy="3381375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306BCAFE-7754-6BA7-DF6F-066E22C8FA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2357" y="1176370"/>
              <a:ext cx="4553313" cy="3381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>
              <a:extLst>
                <a:ext uri="{FF2B5EF4-FFF2-40B4-BE49-F238E27FC236}">
                  <a16:creationId xmlns:a16="http://schemas.microsoft.com/office/drawing/2014/main" id="{B5C9447A-C898-85AC-D0D9-4A3E7D74212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65670" y="1176370"/>
              <a:ext cx="4348366" cy="3381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B8430196-7DBF-5CB4-14CB-5CC9831CF7F0}"/>
              </a:ext>
            </a:extLst>
          </p:cNvPr>
          <p:cNvSpPr txBox="1"/>
          <p:nvPr/>
        </p:nvSpPr>
        <p:spPr>
          <a:xfrm>
            <a:off x="853440" y="5581208"/>
            <a:ext cx="1051124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Left: field measurements of total canopy light interception (TCLI) with a light bar that is progressively shifted along the row to catch the whole-canopy shadow cast onto the ground. Right: a group of three vines featuring the  whole-canopy gas exchange system.  Picture taken on  8 July 2022. 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9799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oni Stefano</dc:creator>
  <cp:lastModifiedBy>Poni Stefano</cp:lastModifiedBy>
  <cp:revision>1</cp:revision>
  <dcterms:created xsi:type="dcterms:W3CDTF">2023-04-07T07:43:37Z</dcterms:created>
  <dcterms:modified xsi:type="dcterms:W3CDTF">2023-07-03T10:29:14Z</dcterms:modified>
</cp:coreProperties>
</file>